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786813" cy="57785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1C6CD-930F-4CA3-B5F0-FB6B63AE26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746928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58800" y="3480480"/>
            <a:ext cx="746928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4115D-BCEB-4855-8BB6-E0834C8F8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48632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58800" y="34804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486320" y="34804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26306-2F00-4714-ACF2-65237087A7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84200" y="16696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709600" y="16696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58800" y="34804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84200" y="34804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709600" y="3480480"/>
            <a:ext cx="24048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4D1A3-AF61-496E-9D49-1D36348EB0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58800" y="1669680"/>
            <a:ext cx="7469280" cy="3467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82DBD-8226-4C23-9D60-E85C21A4EE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746928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EED90-919D-4CD7-80F5-6287B4B8DB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364500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486320" y="1669680"/>
            <a:ext cx="364500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54AFD-5E44-405E-BDBE-A47AFEB181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C55BF-BF51-4691-BE55-0D67CD1B12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58800" y="514440"/>
            <a:ext cx="7469280" cy="446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79774-D8E3-49F4-AB3B-BEC98FFA57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486320" y="1669680"/>
            <a:ext cx="364500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58800" y="34804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5521E-38D9-4404-B55A-574238CD7D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364500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48632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486320" y="34804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3F004-5EC6-434F-896D-2416763F6F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5880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486320" y="1669680"/>
            <a:ext cx="364500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58800" y="3480480"/>
            <a:ext cx="7469280" cy="16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FB28C-9D1C-4FBC-9E28-181902289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58800" y="514440"/>
            <a:ext cx="7469280" cy="96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58800" y="1669680"/>
            <a:ext cx="7469280" cy="346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3000"/>
          </a:bodyPr>
          <a:p>
            <a:pPr marL="284400" indent="-28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16680" indent="-2372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48600" indent="-1897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28040" indent="-189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707480" indent="-189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707480" indent="-189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707480" indent="-189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8800" y="5263920"/>
            <a:ext cx="1830240" cy="38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02040" y="5263920"/>
            <a:ext cx="2782800" cy="38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297120" y="5263920"/>
            <a:ext cx="1830600" cy="38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B5402D-35F1-4BE0-8B63-768CF7A29B2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 txBox="1"/>
          <p:nvPr/>
        </p:nvSpPr>
        <p:spPr>
          <a:xfrm>
            <a:off x="3002040" y="5263920"/>
            <a:ext cx="2782800" cy="38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 txBox="1"/>
          <p:nvPr/>
        </p:nvSpPr>
        <p:spPr>
          <a:xfrm>
            <a:off x="658800" y="5263920"/>
            <a:ext cx="1830240" cy="38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668840" y="3733920"/>
            <a:ext cx="327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50    0    0.5   1.5   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5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 15    50     </a:t>
            </a:r>
            <a:r>
              <a:rPr b="0" lang="en-GB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77080" y="1501920"/>
            <a:ext cx="964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P-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90Rs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135080" y="2286000"/>
            <a:ext cx="1326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Female-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41560" y="5029200"/>
            <a:ext cx="1326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Female-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951080" y="5029200"/>
            <a:ext cx="237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Male-A donation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951080" y="2286000"/>
            <a:ext cx="237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Male-A donation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4745160" y="4038480"/>
            <a:ext cx="2570040" cy="905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4759200" y="1333440"/>
            <a:ext cx="2556000" cy="825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628560" y="4038480"/>
            <a:ext cx="2494080" cy="914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2" name=""/>
          <p:cNvSpPr/>
          <p:nvPr/>
        </p:nvSpPr>
        <p:spPr>
          <a:xfrm>
            <a:off x="3125880" y="1627200"/>
            <a:ext cx="153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125880" y="1855800"/>
            <a:ext cx="153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263760" y="162720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327800" y="1630440"/>
            <a:ext cx="152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327800" y="1859040"/>
            <a:ext cx="152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464600" y="163044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321680" y="437688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461360" y="4114800"/>
            <a:ext cx="3240" cy="262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29120" y="427032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29120" y="449892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270240" y="4270320"/>
            <a:ext cx="0" cy="228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82320" y="103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433760" y="28195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422600" y="76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82320" y="28195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339920" y="941400"/>
            <a:ext cx="16761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86640" y="60948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648800" y="60948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AO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03280" y="990720"/>
            <a:ext cx="3963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50    0    0.5  1.5   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5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 15    50      </a:t>
            </a:r>
            <a:r>
              <a:rPr b="0" lang="en-GB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11280" y="941400"/>
            <a:ext cx="377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562720" y="941400"/>
            <a:ext cx="16761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500000" y="60948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869800" y="60948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AO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722840" y="990720"/>
            <a:ext cx="335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50    0    0.5  1.5   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5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 15    50     </a:t>
            </a:r>
            <a:r>
              <a:rPr b="0" lang="en-GB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722840" y="952560"/>
            <a:ext cx="4604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371600" y="3657600"/>
            <a:ext cx="167472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83400" y="332568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679040" y="332568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AO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34960" y="3706920"/>
            <a:ext cx="3962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50    0    0.5  1.5    </a:t>
            </a: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5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   15    50     </a:t>
            </a:r>
            <a:r>
              <a:rPr b="0" lang="en-GB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11280" y="3657600"/>
            <a:ext cx="377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505480" y="3657600"/>
            <a:ext cx="17510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490280" y="332568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C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888880" y="332568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GSAO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722840" y="3657600"/>
            <a:ext cx="4604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7315200" y="412740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457760" y="1474920"/>
            <a:ext cx="964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P-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90Rs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277080" y="4114800"/>
            <a:ext cx="964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P-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90Rs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7461720" y="3962520"/>
            <a:ext cx="964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P-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90Rs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4"/>
          <a:stretch/>
        </p:blipFill>
        <p:spPr>
          <a:xfrm>
            <a:off x="631800" y="1322280"/>
            <a:ext cx="2490840" cy="849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06T12:00:28Z</dcterms:created>
  <dc:creator>everybody</dc:creator>
  <dc:description/>
  <dc:language>en-US</dc:language>
  <cp:lastModifiedBy>everybody</cp:lastModifiedBy>
  <dcterms:modified xsi:type="dcterms:W3CDTF">2006-03-06T12:17:14Z</dcterms:modified>
  <cp:revision>2</cp:revision>
  <dc:subject/>
  <dc:title>PowerPoint Presentation</dc:title>
</cp:coreProperties>
</file>